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04" d="100"/>
          <a:sy n="104" d="100"/>
        </p:scale>
        <p:origin x="232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7EBD88-A9D9-BEB4-F99D-AD0468AA08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4D010A-BA5E-068F-8372-D407249120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D59FA1-0557-E085-0E04-F32C2EB14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1960F2-2DB8-BB0D-4C4C-252373F5B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55B658-AFFA-EAA3-C0BE-3CD532ED2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35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37775A-D2EC-FDDA-D39B-11D2C062C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FE47FA-413F-30F7-2BC8-B075F98B3E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58E13F-3AC4-8B9B-1E1C-29F6C85EB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4BB03F-5F67-6402-B8FC-D74C77BC0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A36527-99CF-F15B-9AD7-452E3E853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718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5D879E-5992-5A46-2D43-0A469F3956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37D114-6DF7-C73E-BD37-4BF1ADA61F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3F2630-E735-0B4F-8376-A6506F485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7590F-2A1F-E0AB-3EF4-4179474FEA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A8097C-C2A4-BAD3-5C4C-0A2F3B612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326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C75971-93FB-2550-744B-1D778BBCAD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0B3408-FA38-3240-013A-3C7D731BC9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2FE406-BD36-161F-A4DC-0946D5B22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321EFC-0DC2-6E44-6DCC-6082624B4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0F91DF-1F2D-C8AE-2380-EC1B901EC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207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2A4287-AF28-B367-0572-A9AA8D6881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D731FB-EFC4-FC6D-A2CC-C010FE2DF2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8FD9A-CAC0-6243-0521-A5C03B4CE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7A9931-38C4-698F-EE73-590678ABF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09743-682B-D055-D050-0F22501D7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592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BFF20-1B98-EE94-9DEE-52181D5871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BF9697-8A55-531A-CF0B-42BBEC67B5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522081-62A8-F5C7-62F7-9CED3A07DF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0C5711-21B4-0F26-C4D1-4310FC486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01AD98-CE7D-EBAE-74D7-CAA9141FC0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CAF218-1565-9865-6D4B-B219683B3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718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13C2D8-0B06-1A24-C601-D809D4B9D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0D8182-CD24-C22E-4EE9-B83A169303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34940F-67CE-CB0B-2B47-C72476CFC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984CE2-ECAE-1E3F-D2D3-9175AF54BB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76668C-6A27-5882-CBD5-F18D7D9DA6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7DA7DC-67BB-5A34-7A36-F10F1A9283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71D66D-10BF-332B-E7A6-7D2360C3D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3A3FC5-FBEE-2B83-309A-EFC9F6E92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84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EE30D1-3F9F-EA92-5FEF-B623B1BA14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7BCC10F-C345-0C62-0ACD-EBC055C7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DA867B-23AB-6037-F796-E9F485A24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9D7163-2F1D-C667-E371-712B9F08D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396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BC0DD4-20B3-5770-8BB4-61FF1186B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B5F2B7F-B542-2607-1AE9-30A553B15D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FA8575-B9DC-2A42-EACF-D05A7DD24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811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B0EF4-7748-4EF1-C1A6-2F090BCF07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32545E-4C5D-889E-6913-AF16A901E4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87A0D4-F98D-0342-1423-F9F39243D1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1CB57B-FA6D-ED9A-C361-1D0D4B386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98CEB1-1FAC-680A-D8E4-91CEFDF49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8D5247-0C99-9DD0-F3F0-87F29D511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301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5B0E4A-661A-E515-AB31-7153C597DD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1380F84-E1F8-5E05-DD31-C5C86D16AF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DA46A2-90FE-CA67-DD70-92AE5EEA8F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A0D1A5-C426-1410-FA2E-78BBD7CCB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338200-0CAB-D1FD-7317-472D3665A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5715FD-0DD5-D4BE-1226-EFCE138A9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205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1DF980-12F3-C4F9-A86E-3D9D5080C2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08E82C-F65A-01DD-3B56-CF81C1E6CD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A10C47-80EF-B7FB-B304-5990F31627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4AFEF4-19EE-7348-9613-A17761D50EC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3EA88C-7E02-13EF-F2BD-79A849F30E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BDD710-16DA-2D56-785A-1820FEFA7C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F75436-B34C-B74C-B802-9C9225C28F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223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1102FF0-F643-DB60-3850-0A2DF6D5ED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4262" y="4072239"/>
            <a:ext cx="1803400" cy="177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5BA93C0-D462-B032-BE06-ED846A15F2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6155" y="4072239"/>
            <a:ext cx="1803400" cy="1778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EF5401D-8D52-62BD-52A4-46A30D0FFA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47582" y="4060877"/>
            <a:ext cx="1803400" cy="1778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0B9AF1D-1366-C3F0-1C90-B23FBBFCA41B}"/>
              </a:ext>
            </a:extLst>
          </p:cNvPr>
          <p:cNvSpPr txBox="1"/>
          <p:nvPr/>
        </p:nvSpPr>
        <p:spPr>
          <a:xfrm>
            <a:off x="2786051" y="5431229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48BE92-B5E9-F9CB-7035-2822DD586051}"/>
              </a:ext>
            </a:extLst>
          </p:cNvPr>
          <p:cNvSpPr txBox="1"/>
          <p:nvPr/>
        </p:nvSpPr>
        <p:spPr>
          <a:xfrm>
            <a:off x="2786050" y="493434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5B9B086-2DD2-0F6E-A5CC-1B08AF6C3DE5}"/>
              </a:ext>
            </a:extLst>
          </p:cNvPr>
          <p:cNvSpPr txBox="1"/>
          <p:nvPr/>
        </p:nvSpPr>
        <p:spPr>
          <a:xfrm>
            <a:off x="2741569" y="4372282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5347C9-C2FD-FF67-253D-BE74BE8D8E9E}"/>
              </a:ext>
            </a:extLst>
          </p:cNvPr>
          <p:cNvSpPr txBox="1"/>
          <p:nvPr/>
        </p:nvSpPr>
        <p:spPr>
          <a:xfrm>
            <a:off x="1928790" y="5431229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20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8B50817-61BB-085E-773A-B96B9CED2D38}"/>
              </a:ext>
            </a:extLst>
          </p:cNvPr>
          <p:cNvSpPr txBox="1"/>
          <p:nvPr/>
        </p:nvSpPr>
        <p:spPr>
          <a:xfrm>
            <a:off x="1059641" y="4901756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639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EE08745-98F6-5194-1F1F-0AD42C6513BF}"/>
              </a:ext>
            </a:extLst>
          </p:cNvPr>
          <p:cNvSpPr txBox="1"/>
          <p:nvPr/>
        </p:nvSpPr>
        <p:spPr>
          <a:xfrm>
            <a:off x="1059641" y="4355986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7070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97C9D8F4-13A7-FBB1-5BA1-5EA724A65FFD}"/>
              </a:ext>
            </a:extLst>
          </p:cNvPr>
          <p:cNvCxnSpPr/>
          <p:nvPr/>
        </p:nvCxnSpPr>
        <p:spPr>
          <a:xfrm>
            <a:off x="1231647" y="5980099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115CE4E3-4755-5A91-26B2-E2F93C99AA41}"/>
              </a:ext>
            </a:extLst>
          </p:cNvPr>
          <p:cNvSpPr txBox="1"/>
          <p:nvPr/>
        </p:nvSpPr>
        <p:spPr>
          <a:xfrm>
            <a:off x="1978218" y="5838877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 69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E9A7D34-3ABF-DB35-E3C9-E729B7ED9E58}"/>
              </a:ext>
            </a:extLst>
          </p:cNvPr>
          <p:cNvSpPr txBox="1"/>
          <p:nvPr/>
        </p:nvSpPr>
        <p:spPr>
          <a:xfrm>
            <a:off x="5805222" y="5447702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577E8AB-3D42-A961-9EE0-F4D002BB6004}"/>
              </a:ext>
            </a:extLst>
          </p:cNvPr>
          <p:cNvSpPr txBox="1"/>
          <p:nvPr/>
        </p:nvSpPr>
        <p:spPr>
          <a:xfrm>
            <a:off x="5805221" y="4950820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A21A39A-31D3-A037-4CA1-1BE14588397D}"/>
              </a:ext>
            </a:extLst>
          </p:cNvPr>
          <p:cNvSpPr txBox="1"/>
          <p:nvPr/>
        </p:nvSpPr>
        <p:spPr>
          <a:xfrm>
            <a:off x="5760740" y="4388755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021B303-BDFB-E20A-F0F3-48B425C0EA91}"/>
              </a:ext>
            </a:extLst>
          </p:cNvPr>
          <p:cNvSpPr txBox="1"/>
          <p:nvPr/>
        </p:nvSpPr>
        <p:spPr>
          <a:xfrm>
            <a:off x="4947961" y="5447702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20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F6EFBF0-9A50-D990-A9CE-E8BE3BCCFC12}"/>
              </a:ext>
            </a:extLst>
          </p:cNvPr>
          <p:cNvSpPr txBox="1"/>
          <p:nvPr/>
        </p:nvSpPr>
        <p:spPr>
          <a:xfrm>
            <a:off x="4078812" y="4918229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623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C5D6B31-7E01-56AB-B051-9441000BDF07}"/>
              </a:ext>
            </a:extLst>
          </p:cNvPr>
          <p:cNvSpPr txBox="1"/>
          <p:nvPr/>
        </p:nvSpPr>
        <p:spPr>
          <a:xfrm>
            <a:off x="4078812" y="4372459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136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88078FEE-0375-AF0F-E339-5F293559E089}"/>
              </a:ext>
            </a:extLst>
          </p:cNvPr>
          <p:cNvCxnSpPr/>
          <p:nvPr/>
        </p:nvCxnSpPr>
        <p:spPr>
          <a:xfrm>
            <a:off x="4250818" y="5996572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6AF3D608-24FA-988A-F419-24421F3607CC}"/>
              </a:ext>
            </a:extLst>
          </p:cNvPr>
          <p:cNvSpPr txBox="1"/>
          <p:nvPr/>
        </p:nvSpPr>
        <p:spPr>
          <a:xfrm>
            <a:off x="4997389" y="5855350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 69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22597FF-CB76-F304-3D94-EA1D0DB26E26}"/>
              </a:ext>
            </a:extLst>
          </p:cNvPr>
          <p:cNvSpPr txBox="1"/>
          <p:nvPr/>
        </p:nvSpPr>
        <p:spPr>
          <a:xfrm>
            <a:off x="8882074" y="5422989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4AC3CAF-8045-184B-BFA9-587DF79A4929}"/>
              </a:ext>
            </a:extLst>
          </p:cNvPr>
          <p:cNvSpPr txBox="1"/>
          <p:nvPr/>
        </p:nvSpPr>
        <p:spPr>
          <a:xfrm>
            <a:off x="8882073" y="492610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2680C5B-A17C-E19C-7691-1BBAFE49BFA6}"/>
              </a:ext>
            </a:extLst>
          </p:cNvPr>
          <p:cNvSpPr txBox="1"/>
          <p:nvPr/>
        </p:nvSpPr>
        <p:spPr>
          <a:xfrm>
            <a:off x="8837592" y="4364042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5D89B74-AE2D-6563-A327-A82312B33D27}"/>
              </a:ext>
            </a:extLst>
          </p:cNvPr>
          <p:cNvSpPr txBox="1"/>
          <p:nvPr/>
        </p:nvSpPr>
        <p:spPr>
          <a:xfrm>
            <a:off x="8024813" y="5422989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20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1F6F6CF-D8B2-B3D5-ACC9-3D37C153DD81}"/>
              </a:ext>
            </a:extLst>
          </p:cNvPr>
          <p:cNvSpPr txBox="1"/>
          <p:nvPr/>
        </p:nvSpPr>
        <p:spPr>
          <a:xfrm>
            <a:off x="7155664" y="4893516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606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14989F1-B752-4074-AB3B-6B8553D95702}"/>
              </a:ext>
            </a:extLst>
          </p:cNvPr>
          <p:cNvSpPr txBox="1"/>
          <p:nvPr/>
        </p:nvSpPr>
        <p:spPr>
          <a:xfrm>
            <a:off x="7155664" y="4347746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5869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8E15D0CE-996B-7114-D645-C5C68F72E975}"/>
              </a:ext>
            </a:extLst>
          </p:cNvPr>
          <p:cNvCxnSpPr/>
          <p:nvPr/>
        </p:nvCxnSpPr>
        <p:spPr>
          <a:xfrm>
            <a:off x="7327670" y="5971859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61790AFB-415A-CDE2-1FD0-B1AA74766F81}"/>
              </a:ext>
            </a:extLst>
          </p:cNvPr>
          <p:cNvSpPr txBox="1"/>
          <p:nvPr/>
        </p:nvSpPr>
        <p:spPr>
          <a:xfrm>
            <a:off x="8074241" y="5830637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 69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BAF9F719-A6C8-E637-F1BF-FD9E4106D8F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6612" y="1180550"/>
            <a:ext cx="1803400" cy="17780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96AAD4F7-6D1A-08DA-6344-B892273C59F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07912" y="1180550"/>
            <a:ext cx="1803400" cy="1778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E93427E8-963D-00B3-7233-214D175951E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47582" y="1133185"/>
            <a:ext cx="1803400" cy="177800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603B8185-2A18-478F-FD1E-C34EF5571103}"/>
              </a:ext>
            </a:extLst>
          </p:cNvPr>
          <p:cNvSpPr txBox="1"/>
          <p:nvPr/>
        </p:nvSpPr>
        <p:spPr>
          <a:xfrm>
            <a:off x="2790167" y="2556218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D2DF13E-BFC3-8A5E-F062-55BFE59475BD}"/>
              </a:ext>
            </a:extLst>
          </p:cNvPr>
          <p:cNvSpPr txBox="1"/>
          <p:nvPr/>
        </p:nvSpPr>
        <p:spPr>
          <a:xfrm>
            <a:off x="2790166" y="205933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841DA3E-5E02-A09B-1F6E-B80D504DFC17}"/>
              </a:ext>
            </a:extLst>
          </p:cNvPr>
          <p:cNvSpPr txBox="1"/>
          <p:nvPr/>
        </p:nvSpPr>
        <p:spPr>
          <a:xfrm>
            <a:off x="2745685" y="1497271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5DEA8CD-9332-AC72-E159-5D2210ACAD52}"/>
              </a:ext>
            </a:extLst>
          </p:cNvPr>
          <p:cNvSpPr txBox="1"/>
          <p:nvPr/>
        </p:nvSpPr>
        <p:spPr>
          <a:xfrm>
            <a:off x="1932906" y="2556218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3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BD180A7-6447-6071-088E-38BD6A5CA06E}"/>
              </a:ext>
            </a:extLst>
          </p:cNvPr>
          <p:cNvSpPr txBox="1"/>
          <p:nvPr/>
        </p:nvSpPr>
        <p:spPr>
          <a:xfrm>
            <a:off x="1063757" y="2026745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1353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8725493-357F-E2B9-79DB-ED1CB66BFF6F}"/>
              </a:ext>
            </a:extLst>
          </p:cNvPr>
          <p:cNvSpPr txBox="1"/>
          <p:nvPr/>
        </p:nvSpPr>
        <p:spPr>
          <a:xfrm>
            <a:off x="1063757" y="1480975"/>
            <a:ext cx="9044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2145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37A2AFD-CB10-7D28-051B-4EA3084133F1}"/>
              </a:ext>
            </a:extLst>
          </p:cNvPr>
          <p:cNvCxnSpPr/>
          <p:nvPr/>
        </p:nvCxnSpPr>
        <p:spPr>
          <a:xfrm>
            <a:off x="1235763" y="3105088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ACD17F98-F144-7963-0378-B6CAA79BCD4C}"/>
              </a:ext>
            </a:extLst>
          </p:cNvPr>
          <p:cNvSpPr txBox="1"/>
          <p:nvPr/>
        </p:nvSpPr>
        <p:spPr>
          <a:xfrm>
            <a:off x="1982334" y="2963866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 47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54C607B-01D8-7FE6-1329-D5CF1AF60886}"/>
              </a:ext>
            </a:extLst>
          </p:cNvPr>
          <p:cNvSpPr txBox="1"/>
          <p:nvPr/>
        </p:nvSpPr>
        <p:spPr>
          <a:xfrm>
            <a:off x="5809338" y="257269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92C2366-0F3B-5CF3-8C94-63EB1B2A21FA}"/>
              </a:ext>
            </a:extLst>
          </p:cNvPr>
          <p:cNvSpPr txBox="1"/>
          <p:nvPr/>
        </p:nvSpPr>
        <p:spPr>
          <a:xfrm>
            <a:off x="5809337" y="2075809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BA5D297-8FB3-8A00-7BAF-8D8C1F67280E}"/>
              </a:ext>
            </a:extLst>
          </p:cNvPr>
          <p:cNvSpPr txBox="1"/>
          <p:nvPr/>
        </p:nvSpPr>
        <p:spPr>
          <a:xfrm>
            <a:off x="5764856" y="1513744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20696F1-2864-BD26-527D-5D1991147E36}"/>
              </a:ext>
            </a:extLst>
          </p:cNvPr>
          <p:cNvSpPr txBox="1"/>
          <p:nvPr/>
        </p:nvSpPr>
        <p:spPr>
          <a:xfrm>
            <a:off x="4952077" y="2572691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C867076-13EA-9F7E-08BD-6E7CA19444A3}"/>
              </a:ext>
            </a:extLst>
          </p:cNvPr>
          <p:cNvSpPr txBox="1"/>
          <p:nvPr/>
        </p:nvSpPr>
        <p:spPr>
          <a:xfrm>
            <a:off x="4082928" y="2043218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13088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75EC7AE-7428-9C5B-83BB-13B0264C8761}"/>
              </a:ext>
            </a:extLst>
          </p:cNvPr>
          <p:cNvSpPr txBox="1"/>
          <p:nvPr/>
        </p:nvSpPr>
        <p:spPr>
          <a:xfrm>
            <a:off x="4082928" y="1497448"/>
            <a:ext cx="9044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2876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BB74B7E3-ECA2-F3F0-E3FB-4F1230F1F0E1}"/>
              </a:ext>
            </a:extLst>
          </p:cNvPr>
          <p:cNvCxnSpPr/>
          <p:nvPr/>
        </p:nvCxnSpPr>
        <p:spPr>
          <a:xfrm>
            <a:off x="4254934" y="3121561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D677896A-4239-027A-9A10-E6B02A86CCED}"/>
              </a:ext>
            </a:extLst>
          </p:cNvPr>
          <p:cNvSpPr txBox="1"/>
          <p:nvPr/>
        </p:nvSpPr>
        <p:spPr>
          <a:xfrm>
            <a:off x="5001505" y="2980339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 47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43E6D95-0C2F-5146-4871-AA706DD2DF4E}"/>
              </a:ext>
            </a:extLst>
          </p:cNvPr>
          <p:cNvSpPr txBox="1"/>
          <p:nvPr/>
        </p:nvSpPr>
        <p:spPr>
          <a:xfrm>
            <a:off x="8886190" y="2547978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8BE8802-A678-A6BE-E871-FB62C985D2A4}"/>
              </a:ext>
            </a:extLst>
          </p:cNvPr>
          <p:cNvSpPr txBox="1"/>
          <p:nvPr/>
        </p:nvSpPr>
        <p:spPr>
          <a:xfrm>
            <a:off x="8886189" y="205109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08585D6-9BCC-A986-9F92-47514D1FEEDF}"/>
              </a:ext>
            </a:extLst>
          </p:cNvPr>
          <p:cNvSpPr txBox="1"/>
          <p:nvPr/>
        </p:nvSpPr>
        <p:spPr>
          <a:xfrm>
            <a:off x="8841708" y="1489031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D4E97B5-9CE2-8853-9A14-CF6B416E3A1D}"/>
              </a:ext>
            </a:extLst>
          </p:cNvPr>
          <p:cNvSpPr txBox="1"/>
          <p:nvPr/>
        </p:nvSpPr>
        <p:spPr>
          <a:xfrm>
            <a:off x="8028929" y="2547978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3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D8859CC-6E1F-5ED1-87CD-D9F529928A78}"/>
              </a:ext>
            </a:extLst>
          </p:cNvPr>
          <p:cNvSpPr txBox="1"/>
          <p:nvPr/>
        </p:nvSpPr>
        <p:spPr>
          <a:xfrm>
            <a:off x="7159780" y="2018505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12738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9F47AFE-D26B-FAFD-5049-BB9BD2D486D9}"/>
              </a:ext>
            </a:extLst>
          </p:cNvPr>
          <p:cNvSpPr txBox="1"/>
          <p:nvPr/>
        </p:nvSpPr>
        <p:spPr>
          <a:xfrm>
            <a:off x="7159780" y="1472735"/>
            <a:ext cx="9044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1657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922CDDE2-6785-19E7-5800-6AD349B6A61D}"/>
              </a:ext>
            </a:extLst>
          </p:cNvPr>
          <p:cNvCxnSpPr/>
          <p:nvPr/>
        </p:nvCxnSpPr>
        <p:spPr>
          <a:xfrm>
            <a:off x="7331786" y="3096848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852E924C-C1CB-8D2D-09AE-07E32EA4136A}"/>
              </a:ext>
            </a:extLst>
          </p:cNvPr>
          <p:cNvSpPr txBox="1"/>
          <p:nvPr/>
        </p:nvSpPr>
        <p:spPr>
          <a:xfrm>
            <a:off x="8078357" y="2955626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 47</a:t>
            </a:r>
          </a:p>
        </p:txBody>
      </p:sp>
    </p:spTree>
    <p:extLst>
      <p:ext uri="{BB962C8B-B14F-4D97-AF65-F5344CB8AC3E}">
        <p14:creationId xmlns:p14="http://schemas.microsoft.com/office/powerpoint/2010/main" val="247279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84</Words>
  <Application>Microsoft Macintosh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ngh, Satya (NIH/NIAID) [E]</dc:creator>
  <cp:lastModifiedBy>Singh, Satya (NIH/NIAID) [E]</cp:lastModifiedBy>
  <cp:revision>3</cp:revision>
  <dcterms:created xsi:type="dcterms:W3CDTF">2025-07-23T14:01:16Z</dcterms:created>
  <dcterms:modified xsi:type="dcterms:W3CDTF">2025-07-23T14:29:55Z</dcterms:modified>
</cp:coreProperties>
</file>